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902" autoAdjust="0"/>
    <p:restoredTop sz="94660"/>
  </p:normalViewPr>
  <p:slideViewPr>
    <p:cSldViewPr snapToGrid="0">
      <p:cViewPr>
        <p:scale>
          <a:sx n="95" d="100"/>
          <a:sy n="95" d="100"/>
        </p:scale>
        <p:origin x="-1824" y="-330"/>
      </p:cViewPr>
      <p:guideLst>
        <p:guide orient="horz" pos="2160"/>
        <p:guide pos="575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AD1E7C-173D-4C54-A492-DCF39E681DEB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04673B-817B-4D15-9999-9A0D0D93BBA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835732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9A3E03-7573-443E-BB56-1D9D19D5AA83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B1800B-F9E9-4AF8-97E6-AB16918440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2565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891044-7152-490C-B4D7-59AA2785A9F4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840E04-F40C-408B-A52F-90A22196AED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5211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20EA83-7ACD-4F41-955C-334272CAFA5C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6AAAE7-468C-40B0-9469-B61D8248323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129901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586CBA-94D9-48D6-BD13-F7171D058965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37B5AA-8F52-4ED7-BA1D-968AA7A72356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17314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F89093-A9B5-4248-9C00-C3A412761E8C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2FBE9C-BE92-4582-A980-7574E310427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460026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CA4D87-E08C-44EB-940B-4BCBF802E195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95A264-BC37-4CDB-B354-3D251E2C6D1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2142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E9DA60-86AD-43C7-AC73-F0D2C9AAD5EB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384B80-27B2-460D-B3DF-5BC11CC247C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087013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379E4A-BBCE-4D70-B4C3-CDC220999FA1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6EA14B-DEE7-4B1D-A254-96BC0FF6D46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69432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65399D-7E1B-42B9-867A-AE2F594690F3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A3A4A0-4CA8-4824-86BA-9F723E76F89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6286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7F09FB-7166-4AEB-AC5A-E56352791858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F55A34-0722-4D36-9B45-1693B7AC477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17693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F242974B-1994-42DA-BCAE-6C355ABD00A1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B40CBB3B-F53F-4167-82FF-EF64EBCBECB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MS PGothic" pitchFamily="34" charset="-128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9860072"/>
              </p:ext>
            </p:extLst>
          </p:nvPr>
        </p:nvGraphicFramePr>
        <p:xfrm>
          <a:off x="1688123" y="1085214"/>
          <a:ext cx="5194998" cy="526534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14177"/>
                <a:gridCol w="1819459"/>
                <a:gridCol w="2361362"/>
              </a:tblGrid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en-US" sz="12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 No</a:t>
                      </a:r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Name/ I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 typ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ma.06G202500.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8 MER3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ine max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ma.16G072300.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AH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ine max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ma.01G038100.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ki2-like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ine max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ma.08G102300.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cQ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ine max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ma.08G174300.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AD box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ine max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MZM2G346278_T02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R3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ea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ays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:6690303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R3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ticum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estivum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bic.004G215600.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R3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rghum bicolor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2g40450.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R3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yza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ativ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3G27730.1</a:t>
                      </a:r>
                      <a:endParaRPr lang="en-US" sz="1200" b="0" i="1" u="none" strike="noStrike" dirty="0">
                        <a:solidFill>
                          <a:srgbClr val="444444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R3 </a:t>
                      </a: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abidopsis thalian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_011263.2</a:t>
                      </a:r>
                      <a:endParaRPr lang="en-US" sz="1200" b="0" i="0" u="none" strike="noStrike" dirty="0">
                        <a:solidFill>
                          <a:srgbClr val="444444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R3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ccharomyces cerevisiae </a:t>
                      </a:r>
                      <a:endParaRPr lang="en-US" sz="1200" b="0" i="1" u="none" strike="noStrike" dirty="0">
                        <a:solidFill>
                          <a:srgbClr val="222222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5G61140.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AD box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abidopsis thalian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11470.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AD box </a:t>
                      </a:r>
                      <a:r>
                        <a:rPr lang="en-US" sz="1200" i="1" u="none" strike="noStrike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yza</a:t>
                      </a:r>
                      <a:r>
                        <a:rPr lang="en-US" sz="1200" i="1" u="none" strike="noStrike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tiv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1G70070.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ki2-like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abidopsis thalian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2g50560.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ki2-like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yza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ativ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3G05740.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cQ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abidopsis thalian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4g40970.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cQ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yza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ativ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626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1G72250.2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AH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abidopsis thalian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2751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12g42160.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AH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yza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ativ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180870" y="677594"/>
            <a:ext cx="8370278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1 Table.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he protein sequences </a:t>
            </a:r>
            <a:r>
              <a:rPr kumimoji="0" lang="en-US" alt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lycine max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St8 MER3 and 18 homologous proteins used for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hylogenetic</a:t>
            </a:r>
            <a:r>
              <a:rPr kumimoji="0" lang="en-US" altLang="en-US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alysis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96123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052</TotalTime>
  <Words>128</Words>
  <Application>Microsoft Office PowerPoint</Application>
  <PresentationFormat>On-screen Show (4:3)</PresentationFormat>
  <Paragraphs>6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owa State University Department of Agronom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umbach, Jordan L [AGRON]</dc:creator>
  <cp:lastModifiedBy>Devinder Sandhu</cp:lastModifiedBy>
  <cp:revision>118</cp:revision>
  <dcterms:created xsi:type="dcterms:W3CDTF">2013-06-12T21:49:42Z</dcterms:created>
  <dcterms:modified xsi:type="dcterms:W3CDTF">2016-01-20T17:38:16Z</dcterms:modified>
</cp:coreProperties>
</file>